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6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313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519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999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60647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234185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5785845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7429935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6529615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4065905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3575630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2813121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64475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99541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8676013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1562950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77415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4750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52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4070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319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217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9992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5296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0655BE-F172-46B3-A217-8F9363369EC6}" type="datetimeFigureOut">
              <a:rPr lang="zh-CN" altLang="en-US" smtClean="0"/>
              <a:t>2020-8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D4259-B6F6-4590-824D-DEF26180A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190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2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67140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TextBox 7"/>
          <p:cNvSpPr txBox="1"/>
          <p:nvPr/>
        </p:nvSpPr>
        <p:spPr>
          <a:xfrm>
            <a:off x="407971" y="988050"/>
            <a:ext cx="3782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log</a:t>
            </a:r>
            <a:r>
              <a:rPr lang="en-US" altLang="zh-CN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al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ocess of MCR-overlapping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7"/>
          <p:cNvSpPr txBox="1"/>
          <p:nvPr/>
        </p:nvSpPr>
        <p:spPr>
          <a:xfrm>
            <a:off x="407971" y="2780184"/>
            <a:ext cx="3813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ular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onent of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R-overlapping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</a:p>
        </p:txBody>
      </p:sp>
      <p:sp>
        <p:nvSpPr>
          <p:cNvPr id="145" name="TextBox 7"/>
          <p:cNvSpPr txBox="1"/>
          <p:nvPr/>
        </p:nvSpPr>
        <p:spPr>
          <a:xfrm>
            <a:off x="407971" y="4860647"/>
            <a:ext cx="37465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 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ecular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nction of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R-overlapping </a:t>
            </a: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</a:p>
        </p:txBody>
      </p:sp>
      <p:grpSp>
        <p:nvGrpSpPr>
          <p:cNvPr id="12" name="组合 11"/>
          <p:cNvGrpSpPr/>
          <p:nvPr/>
        </p:nvGrpSpPr>
        <p:grpSpPr>
          <a:xfrm>
            <a:off x="224187" y="5116086"/>
            <a:ext cx="5829822" cy="3599754"/>
            <a:chOff x="224187" y="5116086"/>
            <a:chExt cx="5829822" cy="3599754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80135" y="5116086"/>
              <a:ext cx="2663236" cy="3250497"/>
            </a:xfrm>
            <a:prstGeom prst="rect">
              <a:avLst/>
            </a:prstGeom>
          </p:spPr>
        </p:pic>
        <p:sp>
          <p:nvSpPr>
            <p:cNvPr id="35" name="文本框 34"/>
            <p:cNvSpPr txBox="1"/>
            <p:nvPr/>
          </p:nvSpPr>
          <p:spPr>
            <a:xfrm>
              <a:off x="878237" y="5371941"/>
              <a:ext cx="24842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anslation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egulator activity, nucleic acid binding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2186337" y="5744563"/>
              <a:ext cx="11761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etrapyrrole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inding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2116487" y="5869532"/>
              <a:ext cx="12460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otein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ntigen binding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2432051" y="6246913"/>
              <a:ext cx="9304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xygen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inding</a:t>
              </a: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224187" y="6367118"/>
              <a:ext cx="31383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xidoreductase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ctivity, acting on NAD(P)H, oxygen as acceptor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2072037" y="6744500"/>
              <a:ext cx="12904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munoglobulin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inding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2597817" y="6864709"/>
              <a:ext cx="764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gG binding</a:t>
              </a: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2548287" y="6994433"/>
              <a:ext cx="8142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eme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inding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2072037" y="7119404"/>
              <a:ext cx="12904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ECT domain binding</a:t>
              </a: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2186337" y="7368189"/>
              <a:ext cx="11761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hlorid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on binding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1564423" y="7616991"/>
              <a:ext cx="17981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CR6 chemokine receptor binding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2186337" y="7741961"/>
              <a:ext cx="11761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arbohydrat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inding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491591" y="5499940"/>
              <a:ext cx="28709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rans-1,2-dihydrobenzene-1,2-diol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dehydrogenase activity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1849787" y="5124823"/>
              <a:ext cx="15127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biquitinyl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ydrolase activity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1027755" y="5249799"/>
              <a:ext cx="23347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biquitin-lik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rotein-specific protease activity</a:t>
              </a: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1119537" y="5617665"/>
              <a:ext cx="22429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iol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dependent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ubiquitinyl hydrolase activity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878237" y="6004562"/>
              <a:ext cx="24843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enanthrene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9,10-monooxygenase activity</a:t>
              </a: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2116487" y="6120009"/>
              <a:ext cx="12460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xygen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arrier activity</a:t>
              </a: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1487837" y="6492635"/>
              <a:ext cx="18746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Ketosteroid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onooxygenase activity</a:t>
              </a: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1754537" y="6617616"/>
              <a:ext cx="16079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danol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dehydrogenase activity</a:t>
              </a: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1637355" y="7242642"/>
              <a:ext cx="17251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steine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typ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eptidase activity</a:t>
              </a: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2045781" y="7488472"/>
              <a:ext cx="12904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emoattractant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ctivity</a:t>
              </a: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1487837" y="7864056"/>
              <a:ext cx="18746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drosterone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dehydrogenase activity</a:t>
              </a: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2329503" y="7989024"/>
              <a:ext cx="10330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mylas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ctivity</a:t>
              </a: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2116487" y="8113992"/>
              <a:ext cx="12460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lpha-amylas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ctivity </a:t>
              </a: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3188525" y="8314480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3698262" y="8314480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4207999" y="8314480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7" name="文本框 66"/>
            <p:cNvSpPr txBox="1"/>
            <p:nvPr/>
          </p:nvSpPr>
          <p:spPr>
            <a:xfrm>
              <a:off x="4717736" y="8314480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8" name="文本框 67"/>
            <p:cNvSpPr txBox="1"/>
            <p:nvPr/>
          </p:nvSpPr>
          <p:spPr>
            <a:xfrm>
              <a:off x="5737209" y="8314480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5227473" y="8314480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5272856" y="5126950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5190947" y="5255360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4371791" y="537424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4279384" y="5497891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5319532" y="563106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4163185" y="5754711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4018393" y="5878358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4480367" y="6002005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4735643" y="6130415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4302248" y="6249299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9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4249863" y="6372946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4017440" y="6501356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4476561" y="6625003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4103161" y="6748650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7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5194739" y="6872297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4278418" y="7000707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4481316" y="712435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4227942" y="7248001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4198433" y="7371648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2" name="文本框 91"/>
            <p:cNvSpPr txBox="1"/>
            <p:nvPr/>
          </p:nvSpPr>
          <p:spPr>
            <a:xfrm>
              <a:off x="4481316" y="7495295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9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4197470" y="7618942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4411780" y="7742589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 smtClean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4275576" y="7866236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4438453" y="7989883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4732776" y="8113530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2" name="文本框 16"/>
            <p:cNvSpPr txBox="1"/>
            <p:nvPr/>
          </p:nvSpPr>
          <p:spPr>
            <a:xfrm>
              <a:off x="3889389" y="8500396"/>
              <a:ext cx="1444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914362"/>
              <a:r>
                <a:rPr lang="en-US" altLang="zh-CN" sz="800" dirty="0"/>
                <a:t>–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altLang="zh-CN" sz="8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djusted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1570340" y="3013609"/>
            <a:ext cx="4603455" cy="1770567"/>
            <a:chOff x="1570340" y="3013609"/>
            <a:chExt cx="4603455" cy="1770567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37388" y="3013609"/>
              <a:ext cx="2654326" cy="1425432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2351003" y="3851613"/>
              <a:ext cx="9714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olgi </a:t>
              </a:r>
              <a:r>
                <a:rPr kumimoji="0" lang="en-US" altLang="zh-CN" sz="800" b="0" i="1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is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cisterna</a:t>
              </a: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570340" y="3206117"/>
              <a:ext cx="17524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ptoglobin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hemoglobin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omplex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268454" y="4174364"/>
              <a:ext cx="10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ood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icroparticle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170754" y="3044743"/>
              <a:ext cx="11519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H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emoglobin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omplex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2603734" y="3367491"/>
              <a:ext cx="7190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olgi stack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2489434" y="3690239"/>
              <a:ext cx="8333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olgi cisterna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971274" y="3528865"/>
              <a:ext cx="13514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olgi cisterna membrane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570340" y="4012987"/>
              <a:ext cx="17524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i="1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</a:t>
              </a:r>
              <a:r>
                <a:rPr kumimoji="0" lang="en-US" altLang="zh-CN" sz="800" b="0" i="1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is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-Golgi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etwork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591131" y="319687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589861" y="4177677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7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881961" y="3032500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4123261" y="3357983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4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4360751" y="3691086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4621101" y="3521269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4969081" y="4014392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2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5638371" y="385219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143670" y="4394029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3997764" y="4394029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4851858" y="4386409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5705953" y="4386409"/>
              <a:ext cx="3168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5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4" name="文本框 16"/>
            <p:cNvSpPr txBox="1"/>
            <p:nvPr/>
          </p:nvSpPr>
          <p:spPr>
            <a:xfrm>
              <a:off x="3845739" y="4568732"/>
              <a:ext cx="1444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914362"/>
              <a:r>
                <a:rPr lang="en-US" altLang="zh-CN" sz="800" dirty="0"/>
                <a:t>–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altLang="zh-CN" sz="8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djusted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1610135" y="1230027"/>
            <a:ext cx="4362050" cy="1344285"/>
            <a:chOff x="1610135" y="1230027"/>
            <a:chExt cx="4362050" cy="1344285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42605" y="1230027"/>
              <a:ext cx="2649109" cy="1037938"/>
            </a:xfrm>
            <a:prstGeom prst="rect">
              <a:avLst/>
            </a:prstGeom>
          </p:spPr>
        </p:pic>
        <p:sp>
          <p:nvSpPr>
            <p:cNvPr id="108" name="文本框 107"/>
            <p:cNvSpPr txBox="1"/>
            <p:nvPr/>
          </p:nvSpPr>
          <p:spPr>
            <a:xfrm>
              <a:off x="2143535" y="1250139"/>
              <a:ext cx="11666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pindl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rganization</a:t>
              </a: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2302284" y="1433155"/>
              <a:ext cx="10079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pindle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ssembly</a:t>
              </a:r>
            </a:p>
          </p:txBody>
        </p:sp>
        <p:sp>
          <p:nvSpPr>
            <p:cNvPr id="110" name="文本框 109"/>
            <p:cNvSpPr txBox="1"/>
            <p:nvPr/>
          </p:nvSpPr>
          <p:spPr>
            <a:xfrm>
              <a:off x="1610135" y="1799187"/>
              <a:ext cx="1700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nadal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esoderm development</a:t>
              </a: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2302284" y="1982202"/>
              <a:ext cx="10079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olgi organization</a:t>
              </a:r>
            </a:p>
          </p:txBody>
        </p:sp>
        <p:sp>
          <p:nvSpPr>
            <p:cNvPr id="113" name="文本框 112"/>
            <p:cNvSpPr txBox="1"/>
            <p:nvPr/>
          </p:nvSpPr>
          <p:spPr>
            <a:xfrm>
              <a:off x="2315394" y="1616171"/>
              <a:ext cx="9948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8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</a:t>
              </a:r>
              <a:r>
                <a:rPr kumimoji="0" lang="en-US" altLang="zh-CN" sz="8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xygen</a:t>
              </a: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ransport</a:t>
              </a:r>
            </a:p>
          </p:txBody>
        </p:sp>
        <p:sp>
          <p:nvSpPr>
            <p:cNvPr id="124" name="文本框 123"/>
            <p:cNvSpPr txBox="1"/>
            <p:nvPr/>
          </p:nvSpPr>
          <p:spPr>
            <a:xfrm>
              <a:off x="4879600" y="124938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9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" name="文本框 124"/>
            <p:cNvSpPr txBox="1"/>
            <p:nvPr/>
          </p:nvSpPr>
          <p:spPr>
            <a:xfrm>
              <a:off x="5370417" y="143619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6" name="文本框 125"/>
            <p:cNvSpPr txBox="1"/>
            <p:nvPr/>
          </p:nvSpPr>
          <p:spPr>
            <a:xfrm>
              <a:off x="4856843" y="1811188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4865047" y="1995264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3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4017746" y="1614885"/>
              <a:ext cx="535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ctr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en-US" altLang="zh-CN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8" name="文本框 137"/>
            <p:cNvSpPr txBox="1"/>
            <p:nvPr/>
          </p:nvSpPr>
          <p:spPr>
            <a:xfrm>
              <a:off x="3182970" y="2226592"/>
              <a:ext cx="251755" cy="22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9" name="文本框 138"/>
            <p:cNvSpPr txBox="1"/>
            <p:nvPr/>
          </p:nvSpPr>
          <p:spPr>
            <a:xfrm>
              <a:off x="4028790" y="2226592"/>
              <a:ext cx="251755" cy="22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0" name="文本框 139"/>
            <p:cNvSpPr txBox="1"/>
            <p:nvPr/>
          </p:nvSpPr>
          <p:spPr>
            <a:xfrm>
              <a:off x="4874610" y="2226592"/>
              <a:ext cx="251755" cy="22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5720430" y="2226592"/>
              <a:ext cx="251755" cy="2219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5" name="文本框 16"/>
            <p:cNvSpPr txBox="1"/>
            <p:nvPr/>
          </p:nvSpPr>
          <p:spPr>
            <a:xfrm>
              <a:off x="3846628" y="2358868"/>
              <a:ext cx="1444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ctr" defTabSz="914362"/>
              <a:r>
                <a:rPr lang="en-US" altLang="zh-CN" sz="800" dirty="0"/>
                <a:t>–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altLang="zh-CN" sz="8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djusted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27955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</TotalTime>
  <Words>194</Words>
  <Application>Microsoft Office PowerPoint</Application>
  <PresentationFormat>A4 纸张(210x297 毫米)</PresentationFormat>
  <Paragraphs>9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1_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艳芳</dc:creator>
  <cp:lastModifiedBy>焦玉霞</cp:lastModifiedBy>
  <cp:revision>87</cp:revision>
  <dcterms:created xsi:type="dcterms:W3CDTF">2018-12-08T09:08:24Z</dcterms:created>
  <dcterms:modified xsi:type="dcterms:W3CDTF">2020-08-12T04:21:12Z</dcterms:modified>
</cp:coreProperties>
</file>